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1113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0772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574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460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995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31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98829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714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045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8108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2569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CCDA18-4645-4350-B15C-A11B9843819C}" type="datetimeFigureOut">
              <a:rPr kumimoji="1" lang="ja-JP" altLang="en-US" smtClean="0"/>
              <a:t>2024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76C2F-FB26-42ED-B48E-47B922F865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5100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/>
          <p:cNvSpPr txBox="1"/>
          <p:nvPr/>
        </p:nvSpPr>
        <p:spPr>
          <a:xfrm>
            <a:off x="686165" y="4342977"/>
            <a:ext cx="1092163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XRD rocking curve of GaN(0002) diffraction in (a) the ELO-GaN layer on Si(111) substrate and (b) the ELO-GaN layer on </a:t>
            </a:r>
            <a:r>
              <a:rPr lang="en-US" altLang="ja-JP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plane sapphire 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substrate. The incident beam was perpendicular to the ELO stripes</a:t>
            </a:r>
            <a:r>
              <a:rPr lang="en-US" altLang="ja-JP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ja-JP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In the graphs, circles mean raw data and solid red lines mean fitting curves.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5176" y="881252"/>
            <a:ext cx="4619048" cy="3038095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9733" y="986014"/>
            <a:ext cx="4533333" cy="29333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345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8</TotalTime>
  <Words>59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>Kyoce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uchi Kazuma　( 武内　一真 )</dc:creator>
  <cp:lastModifiedBy>Takeuchi Kazuma　( 武内　一真 )</cp:lastModifiedBy>
  <cp:revision>10</cp:revision>
  <dcterms:created xsi:type="dcterms:W3CDTF">2023-12-27T04:15:00Z</dcterms:created>
  <dcterms:modified xsi:type="dcterms:W3CDTF">2024-01-08T09:14:15Z</dcterms:modified>
</cp:coreProperties>
</file>